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61" r:id="rId3"/>
    <p:sldId id="262" r:id="rId4"/>
    <p:sldId id="263" r:id="rId5"/>
    <p:sldId id="264" r:id="rId6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46" autoAdjust="0"/>
    <p:restoredTop sz="94660"/>
  </p:normalViewPr>
  <p:slideViewPr>
    <p:cSldViewPr snapToGrid="0">
      <p:cViewPr varScale="1">
        <p:scale>
          <a:sx n="74" d="100"/>
          <a:sy n="74" d="100"/>
        </p:scale>
        <p:origin x="301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82BC15-AD87-42FB-8902-24E05F3ACDB0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561135-AB5E-4B72-A22F-BDD2E61BBEE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853037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85380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03676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61060" y="761294"/>
            <a:ext cx="831354" cy="1212567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65212" y="761294"/>
            <a:ext cx="2410122" cy="1212567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61569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57498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5097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65212" y="3808766"/>
            <a:ext cx="1620738" cy="90782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1675" y="3808766"/>
            <a:ext cx="1620739" cy="90782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36024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90084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6508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09288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31531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707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5FDC2-3605-4B07-A756-7ABF9190BA76}" type="datetimeFigureOut">
              <a:rPr lang="en-IN" smtClean="0"/>
              <a:t>04-04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A0B07D-52F2-4719-AD97-701E2B97818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06931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3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microsoft.com/office/2007/relationships/hdphoto" Target="../media/hdphoto6.wdp"/><Relationship Id="rId7" Type="http://schemas.microsoft.com/office/2007/relationships/hdphoto" Target="../media/hdphoto8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microsoft.com/office/2007/relationships/hdphoto" Target="../media/hdphoto10.wdp"/><Relationship Id="rId5" Type="http://schemas.microsoft.com/office/2007/relationships/hdphoto" Target="../media/hdphoto7.wdp"/><Relationship Id="rId10" Type="http://schemas.openxmlformats.org/officeDocument/2006/relationships/image" Target="../media/image11.png"/><Relationship Id="rId4" Type="http://schemas.openxmlformats.org/officeDocument/2006/relationships/image" Target="../media/image8.png"/><Relationship Id="rId9" Type="http://schemas.microsoft.com/office/2007/relationships/hdphoto" Target="../media/hdphoto9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8804" y="687514"/>
            <a:ext cx="5945082" cy="788327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18804" y="8767181"/>
            <a:ext cx="2763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69165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21063" y="486337"/>
            <a:ext cx="6794181" cy="108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3996"/>
          <a:stretch/>
        </p:blipFill>
        <p:spPr>
          <a:xfrm>
            <a:off x="187034" y="2112500"/>
            <a:ext cx="6549053" cy="103683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  <a14:imgEffect>
                      <a14:colorTemperature colorTemp="88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5333"/>
          <a:stretch/>
        </p:blipFill>
        <p:spPr>
          <a:xfrm>
            <a:off x="-368576" y="3718622"/>
            <a:ext cx="6549125" cy="102240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5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5"/>
          <a:stretch/>
        </p:blipFill>
        <p:spPr>
          <a:xfrm>
            <a:off x="277478" y="5410210"/>
            <a:ext cx="6320455" cy="103205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25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694"/>
          <a:stretch/>
        </p:blipFill>
        <p:spPr>
          <a:xfrm>
            <a:off x="329730" y="6888204"/>
            <a:ext cx="6528270" cy="106361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90944" y="8687492"/>
            <a:ext cx="2763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57903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286"/>
          <a:stretch/>
        </p:blipFill>
        <p:spPr>
          <a:xfrm>
            <a:off x="18000" y="581891"/>
            <a:ext cx="6840000" cy="105987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5881"/>
          <a:stretch/>
        </p:blipFill>
        <p:spPr>
          <a:xfrm>
            <a:off x="-18952" y="2186689"/>
            <a:ext cx="6831921" cy="101648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-1" b="5040"/>
          <a:stretch/>
        </p:blipFill>
        <p:spPr>
          <a:xfrm>
            <a:off x="101128" y="3805510"/>
            <a:ext cx="6840000" cy="102557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5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5262"/>
          <a:stretch/>
        </p:blipFill>
        <p:spPr>
          <a:xfrm>
            <a:off x="82865" y="5452442"/>
            <a:ext cx="6794189" cy="102317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25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666"/>
          <a:stretch/>
        </p:blipFill>
        <p:spPr>
          <a:xfrm>
            <a:off x="-58116" y="7129754"/>
            <a:ext cx="6812020" cy="109361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73946" y="9141252"/>
            <a:ext cx="2763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50412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02232" y="802603"/>
            <a:ext cx="6286226" cy="3594436"/>
            <a:chOff x="402232" y="802603"/>
            <a:chExt cx="6286226" cy="3594436"/>
          </a:xfrm>
        </p:grpSpPr>
        <p:sp>
          <p:nvSpPr>
            <p:cNvPr id="62" name="TextBox 61"/>
            <p:cNvSpPr txBox="1"/>
            <p:nvPr/>
          </p:nvSpPr>
          <p:spPr>
            <a:xfrm>
              <a:off x="649279" y="4120040"/>
              <a:ext cx="16475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. S3.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402232" y="802603"/>
              <a:ext cx="6286226" cy="2909619"/>
              <a:chOff x="586648" y="802603"/>
              <a:chExt cx="6286226" cy="2909619"/>
            </a:xfrm>
          </p:grpSpPr>
          <p:sp>
            <p:nvSpPr>
              <p:cNvPr id="85" name="TextBox 84"/>
              <p:cNvSpPr txBox="1"/>
              <p:nvPr/>
            </p:nvSpPr>
            <p:spPr>
              <a:xfrm>
                <a:off x="1209964" y="894890"/>
                <a:ext cx="11323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ector alone</a:t>
                </a:r>
                <a:endPara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94805" y="1560147"/>
                <a:ext cx="3389670" cy="2152075"/>
              </a:xfrm>
              <a:prstGeom prst="rect">
                <a:avLst/>
              </a:prstGeom>
            </p:spPr>
          </p:pic>
          <p:grpSp>
            <p:nvGrpSpPr>
              <p:cNvPr id="64" name="Group 63"/>
              <p:cNvGrpSpPr/>
              <p:nvPr/>
            </p:nvGrpSpPr>
            <p:grpSpPr>
              <a:xfrm>
                <a:off x="586648" y="1562459"/>
                <a:ext cx="543601" cy="2077436"/>
                <a:chOff x="3383578" y="3493503"/>
                <a:chExt cx="484868" cy="2077436"/>
              </a:xfrm>
            </p:grpSpPr>
            <p:sp>
              <p:nvSpPr>
                <p:cNvPr id="108" name="TextBox 107"/>
                <p:cNvSpPr txBox="1"/>
                <p:nvPr/>
              </p:nvSpPr>
              <p:spPr>
                <a:xfrm>
                  <a:off x="3484694" y="4207009"/>
                  <a:ext cx="36554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5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9" name="TextBox 108"/>
                <p:cNvSpPr txBox="1"/>
                <p:nvPr/>
              </p:nvSpPr>
              <p:spPr>
                <a:xfrm>
                  <a:off x="3476113" y="4633627"/>
                  <a:ext cx="35227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0" name="TextBox 109"/>
                <p:cNvSpPr txBox="1"/>
                <p:nvPr/>
              </p:nvSpPr>
              <p:spPr>
                <a:xfrm>
                  <a:off x="3411973" y="3493503"/>
                  <a:ext cx="4256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6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1" name="TextBox 110"/>
                <p:cNvSpPr txBox="1"/>
                <p:nvPr/>
              </p:nvSpPr>
              <p:spPr>
                <a:xfrm>
                  <a:off x="3481912" y="3866528"/>
                  <a:ext cx="35715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6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2" name="TextBox 111"/>
                <p:cNvSpPr txBox="1"/>
                <p:nvPr/>
              </p:nvSpPr>
              <p:spPr>
                <a:xfrm>
                  <a:off x="3484694" y="4954343"/>
                  <a:ext cx="37514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3" name="TextBox 112"/>
                <p:cNvSpPr txBox="1"/>
                <p:nvPr/>
              </p:nvSpPr>
              <p:spPr>
                <a:xfrm>
                  <a:off x="3383578" y="5293940"/>
                  <a:ext cx="48486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8.4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65" name="Straight Connector 64"/>
              <p:cNvCxnSpPr/>
              <p:nvPr/>
            </p:nvCxnSpPr>
            <p:spPr>
              <a:xfrm flipV="1">
                <a:off x="1019742" y="1535894"/>
                <a:ext cx="322886" cy="2259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66" name="Group 65"/>
              <p:cNvGrpSpPr/>
              <p:nvPr/>
            </p:nvGrpSpPr>
            <p:grpSpPr>
              <a:xfrm>
                <a:off x="982177" y="1103476"/>
                <a:ext cx="441146" cy="480941"/>
                <a:chOff x="4734516" y="2284949"/>
                <a:chExt cx="692640" cy="731728"/>
              </a:xfrm>
            </p:grpSpPr>
            <p:sp>
              <p:nvSpPr>
                <p:cNvPr id="106" name="TextBox 105"/>
                <p:cNvSpPr txBox="1"/>
                <p:nvPr/>
              </p:nvSpPr>
              <p:spPr>
                <a:xfrm>
                  <a:off x="4782806" y="2284949"/>
                  <a:ext cx="360667" cy="4214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7" name="TextBox 106"/>
                <p:cNvSpPr txBox="1"/>
                <p:nvPr/>
              </p:nvSpPr>
              <p:spPr>
                <a:xfrm>
                  <a:off x="4734516" y="2595237"/>
                  <a:ext cx="692640" cy="4214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67" name="Straight Connector 66"/>
              <p:cNvCxnSpPr/>
              <p:nvPr/>
            </p:nvCxnSpPr>
            <p:spPr>
              <a:xfrm>
                <a:off x="2198269" y="1532923"/>
                <a:ext cx="64577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68" name="Group 67"/>
              <p:cNvGrpSpPr/>
              <p:nvPr/>
            </p:nvGrpSpPr>
            <p:grpSpPr>
              <a:xfrm>
                <a:off x="2181523" y="1107417"/>
                <a:ext cx="669512" cy="467525"/>
                <a:chOff x="676222" y="2372042"/>
                <a:chExt cx="1051196" cy="711316"/>
              </a:xfrm>
            </p:grpSpPr>
            <p:sp>
              <p:nvSpPr>
                <p:cNvPr id="103" name="TextBox 102"/>
                <p:cNvSpPr txBox="1"/>
                <p:nvPr/>
              </p:nvSpPr>
              <p:spPr>
                <a:xfrm>
                  <a:off x="857211" y="2372042"/>
                  <a:ext cx="674313" cy="4214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h</a:t>
                  </a:r>
                </a:p>
              </p:txBody>
            </p:sp>
            <p:sp>
              <p:nvSpPr>
                <p:cNvPr id="104" name="TextBox 103"/>
                <p:cNvSpPr txBox="1"/>
                <p:nvPr/>
              </p:nvSpPr>
              <p:spPr>
                <a:xfrm>
                  <a:off x="676222" y="2654522"/>
                  <a:ext cx="370482" cy="4214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5" name="TextBox 104"/>
                <p:cNvSpPr txBox="1"/>
                <p:nvPr/>
              </p:nvSpPr>
              <p:spPr>
                <a:xfrm>
                  <a:off x="1143001" y="2661918"/>
                  <a:ext cx="584417" cy="4214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n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0" name="Group 69"/>
              <p:cNvGrpSpPr/>
              <p:nvPr/>
            </p:nvGrpSpPr>
            <p:grpSpPr>
              <a:xfrm>
                <a:off x="2965970" y="1107417"/>
                <a:ext cx="669512" cy="467525"/>
                <a:chOff x="676222" y="2372042"/>
                <a:chExt cx="1051196" cy="711316"/>
              </a:xfrm>
            </p:grpSpPr>
            <p:sp>
              <p:nvSpPr>
                <p:cNvPr id="100" name="TextBox 99"/>
                <p:cNvSpPr txBox="1"/>
                <p:nvPr/>
              </p:nvSpPr>
              <p:spPr>
                <a:xfrm>
                  <a:off x="857211" y="2372042"/>
                  <a:ext cx="674313" cy="4214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h</a:t>
                  </a:r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676222" y="2654522"/>
                  <a:ext cx="370482" cy="4214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" name="TextBox 101"/>
                <p:cNvSpPr txBox="1"/>
                <p:nvPr/>
              </p:nvSpPr>
              <p:spPr>
                <a:xfrm>
                  <a:off x="1143001" y="2661918"/>
                  <a:ext cx="584417" cy="4214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n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71" name="Straight Connector 70"/>
              <p:cNvCxnSpPr/>
              <p:nvPr/>
            </p:nvCxnSpPr>
            <p:spPr>
              <a:xfrm>
                <a:off x="2975079" y="1533543"/>
                <a:ext cx="64577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72" name="Group 71"/>
              <p:cNvGrpSpPr/>
              <p:nvPr/>
            </p:nvGrpSpPr>
            <p:grpSpPr>
              <a:xfrm>
                <a:off x="3719080" y="1103474"/>
                <a:ext cx="669512" cy="467524"/>
                <a:chOff x="676222" y="2372042"/>
                <a:chExt cx="1051196" cy="711315"/>
              </a:xfrm>
            </p:grpSpPr>
            <p:sp>
              <p:nvSpPr>
                <p:cNvPr id="97" name="TextBox 96"/>
                <p:cNvSpPr txBox="1"/>
                <p:nvPr/>
              </p:nvSpPr>
              <p:spPr>
                <a:xfrm>
                  <a:off x="857211" y="2372042"/>
                  <a:ext cx="674313" cy="4214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</a:t>
                  </a:r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h</a:t>
                  </a:r>
                </a:p>
              </p:txBody>
            </p:sp>
            <p:sp>
              <p:nvSpPr>
                <p:cNvPr id="98" name="TextBox 97"/>
                <p:cNvSpPr txBox="1"/>
                <p:nvPr/>
              </p:nvSpPr>
              <p:spPr>
                <a:xfrm>
                  <a:off x="676222" y="2654522"/>
                  <a:ext cx="370482" cy="4214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9" name="TextBox 98"/>
                <p:cNvSpPr txBox="1"/>
                <p:nvPr/>
              </p:nvSpPr>
              <p:spPr>
                <a:xfrm>
                  <a:off x="1143001" y="2661918"/>
                  <a:ext cx="584417" cy="4214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n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73" name="Straight Connector 72"/>
              <p:cNvCxnSpPr/>
              <p:nvPr/>
            </p:nvCxnSpPr>
            <p:spPr>
              <a:xfrm>
                <a:off x="3728190" y="1529601"/>
                <a:ext cx="64577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74" name="Group 73"/>
              <p:cNvGrpSpPr/>
              <p:nvPr/>
            </p:nvGrpSpPr>
            <p:grpSpPr>
              <a:xfrm>
                <a:off x="1428787" y="1111099"/>
                <a:ext cx="669512" cy="467525"/>
                <a:chOff x="631093" y="2372042"/>
                <a:chExt cx="1051196" cy="711316"/>
              </a:xfrm>
            </p:grpSpPr>
            <p:sp>
              <p:nvSpPr>
                <p:cNvPr id="94" name="TextBox 93"/>
                <p:cNvSpPr txBox="1"/>
                <p:nvPr/>
              </p:nvSpPr>
              <p:spPr>
                <a:xfrm>
                  <a:off x="812082" y="2372042"/>
                  <a:ext cx="594335" cy="4214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 h</a:t>
                  </a:r>
                </a:p>
              </p:txBody>
            </p:sp>
            <p:sp>
              <p:nvSpPr>
                <p:cNvPr id="95" name="TextBox 94"/>
                <p:cNvSpPr txBox="1"/>
                <p:nvPr/>
              </p:nvSpPr>
              <p:spPr>
                <a:xfrm>
                  <a:off x="631093" y="2654522"/>
                  <a:ext cx="370482" cy="4214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" name="TextBox 95"/>
                <p:cNvSpPr txBox="1"/>
                <p:nvPr/>
              </p:nvSpPr>
              <p:spPr>
                <a:xfrm>
                  <a:off x="1097872" y="2661918"/>
                  <a:ext cx="584417" cy="4214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n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75" name="Straight Connector 74"/>
              <p:cNvCxnSpPr/>
              <p:nvPr/>
            </p:nvCxnSpPr>
            <p:spPr>
              <a:xfrm>
                <a:off x="1428315" y="1537225"/>
                <a:ext cx="64577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76" name="Picture 75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421" t="15380" r="33080" b="13866"/>
              <a:stretch/>
            </p:blipFill>
            <p:spPr>
              <a:xfrm>
                <a:off x="4529929" y="1570080"/>
                <a:ext cx="651506" cy="2046396"/>
              </a:xfrm>
              <a:prstGeom prst="rect">
                <a:avLst/>
              </a:prstGeom>
            </p:spPr>
          </p:pic>
          <p:pic>
            <p:nvPicPr>
              <p:cNvPr id="77" name="Picture 76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484" t="16349" r="1484" b="18411"/>
              <a:stretch/>
            </p:blipFill>
            <p:spPr>
              <a:xfrm>
                <a:off x="5318567" y="1560146"/>
                <a:ext cx="645772" cy="2056330"/>
              </a:xfrm>
              <a:prstGeom prst="rect">
                <a:avLst/>
              </a:prstGeom>
            </p:spPr>
          </p:pic>
          <p:cxnSp>
            <p:nvCxnSpPr>
              <p:cNvPr id="78" name="Straight Connector 77"/>
              <p:cNvCxnSpPr/>
              <p:nvPr/>
            </p:nvCxnSpPr>
            <p:spPr>
              <a:xfrm>
                <a:off x="4535188" y="1527314"/>
                <a:ext cx="64577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>
                <a:off x="5326915" y="1525886"/>
                <a:ext cx="64577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80" name="Group 79"/>
              <p:cNvGrpSpPr/>
              <p:nvPr/>
            </p:nvGrpSpPr>
            <p:grpSpPr>
              <a:xfrm>
                <a:off x="4459365" y="1104232"/>
                <a:ext cx="785890" cy="465874"/>
                <a:chOff x="3446191" y="3059241"/>
                <a:chExt cx="700979" cy="465874"/>
              </a:xfrm>
            </p:grpSpPr>
            <p:sp>
              <p:nvSpPr>
                <p:cNvPr id="91" name="TextBox 90"/>
                <p:cNvSpPr txBox="1"/>
                <p:nvPr/>
              </p:nvSpPr>
              <p:spPr>
                <a:xfrm>
                  <a:off x="3605550" y="3059241"/>
                  <a:ext cx="38307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h</a:t>
                  </a:r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>
                  <a:off x="3446191" y="3246692"/>
                  <a:ext cx="38490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P1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>
                  <a:off x="3762266" y="3248116"/>
                  <a:ext cx="38490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P2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1" name="Group 80"/>
              <p:cNvGrpSpPr/>
              <p:nvPr/>
            </p:nvGrpSpPr>
            <p:grpSpPr>
              <a:xfrm>
                <a:off x="5243200" y="1111099"/>
                <a:ext cx="785890" cy="456930"/>
                <a:chOff x="4145526" y="3056093"/>
                <a:chExt cx="700979" cy="456930"/>
              </a:xfrm>
            </p:grpSpPr>
            <p:sp>
              <p:nvSpPr>
                <p:cNvPr id="88" name="TextBox 87"/>
                <p:cNvSpPr txBox="1"/>
                <p:nvPr/>
              </p:nvSpPr>
              <p:spPr>
                <a:xfrm>
                  <a:off x="4295446" y="3056093"/>
                  <a:ext cx="40113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B</a:t>
                  </a:r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>
                  <a:off x="4145526" y="3234600"/>
                  <a:ext cx="38490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P1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4461601" y="3236024"/>
                  <a:ext cx="38490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P2</a:t>
                  </a:r>
                  <a:endPara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2" name="TextBox 81"/>
              <p:cNvSpPr txBox="1"/>
              <p:nvPr/>
            </p:nvSpPr>
            <p:spPr>
              <a:xfrm>
                <a:off x="2181534" y="890114"/>
                <a:ext cx="226694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combinant AlNAC4 protein</a:t>
                </a:r>
                <a:endPara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3" name="Straight Connector 82"/>
              <p:cNvCxnSpPr/>
              <p:nvPr/>
            </p:nvCxnSpPr>
            <p:spPr>
              <a:xfrm>
                <a:off x="2152833" y="1115093"/>
                <a:ext cx="223520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>
                <a:off x="1317839" y="1115093"/>
                <a:ext cx="792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5" name="TextBox 96"/>
              <p:cNvSpPr txBox="1"/>
              <p:nvPr/>
            </p:nvSpPr>
            <p:spPr>
              <a:xfrm>
                <a:off x="1435890" y="1549666"/>
                <a:ext cx="298869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      2        3        4         5        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      </a:t>
                </a:r>
                <a:r>
                  <a:rPr lang="en-I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7       8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TextBox 153"/>
              <p:cNvSpPr txBox="1"/>
              <p:nvPr/>
            </p:nvSpPr>
            <p:spPr>
              <a:xfrm>
                <a:off x="685867" y="802603"/>
                <a:ext cx="3878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.</a:t>
                </a:r>
              </a:p>
            </p:txBody>
          </p:sp>
          <p:sp>
            <p:nvSpPr>
              <p:cNvPr id="117" name="TextBox 95"/>
              <p:cNvSpPr txBox="1"/>
              <p:nvPr/>
            </p:nvSpPr>
            <p:spPr>
              <a:xfrm>
                <a:off x="4445613" y="812002"/>
                <a:ext cx="3465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.</a:t>
                </a:r>
              </a:p>
            </p:txBody>
          </p:sp>
          <p:cxnSp>
            <p:nvCxnSpPr>
              <p:cNvPr id="118" name="Straight Arrow Connector 117"/>
              <p:cNvCxnSpPr/>
              <p:nvPr/>
            </p:nvCxnSpPr>
            <p:spPr>
              <a:xfrm flipH="1">
                <a:off x="2416340" y="2517324"/>
                <a:ext cx="370441" cy="246221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TextBox 118"/>
              <p:cNvSpPr txBox="1"/>
              <p:nvPr/>
            </p:nvSpPr>
            <p:spPr>
              <a:xfrm>
                <a:off x="2732833" y="2327481"/>
                <a:ext cx="8143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NAC4</a:t>
                </a:r>
                <a:endPara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0" name="Straight Arrow Connector 119"/>
              <p:cNvCxnSpPr/>
              <p:nvPr/>
            </p:nvCxnSpPr>
            <p:spPr>
              <a:xfrm flipH="1">
                <a:off x="5960393" y="2896380"/>
                <a:ext cx="224265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TextBox 120"/>
              <p:cNvSpPr txBox="1"/>
              <p:nvPr/>
            </p:nvSpPr>
            <p:spPr>
              <a:xfrm>
                <a:off x="6103976" y="2757880"/>
                <a:ext cx="76889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NAC4</a:t>
                </a:r>
                <a:endPara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9" name="TextBox 95"/>
            <p:cNvSpPr txBox="1"/>
            <p:nvPr/>
          </p:nvSpPr>
          <p:spPr>
            <a:xfrm>
              <a:off x="5046809" y="823483"/>
              <a:ext cx="3465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226990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206502" y="798798"/>
            <a:ext cx="4032313" cy="4437081"/>
            <a:chOff x="2697099" y="861428"/>
            <a:chExt cx="4032313" cy="4437081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97099" y="3025901"/>
              <a:ext cx="4032313" cy="2272608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97099" y="1165478"/>
              <a:ext cx="4032313" cy="1806321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2697099" y="861428"/>
              <a:ext cx="40323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WT                     L33                     L50                   L64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1104637" y="5387800"/>
            <a:ext cx="1647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4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153"/>
          <p:cNvSpPr txBox="1"/>
          <p:nvPr/>
        </p:nvSpPr>
        <p:spPr>
          <a:xfrm>
            <a:off x="843378" y="1026008"/>
            <a:ext cx="377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8" name="TextBox 153"/>
          <p:cNvSpPr txBox="1"/>
          <p:nvPr/>
        </p:nvSpPr>
        <p:spPr>
          <a:xfrm>
            <a:off x="842098" y="2891940"/>
            <a:ext cx="377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0843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6</TotalTime>
  <Words>85</Words>
  <Application>Microsoft Office PowerPoint</Application>
  <PresentationFormat>A4 Paper (210x297 mm)</PresentationFormat>
  <Paragraphs>4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KSON</dc:creator>
  <cp:lastModifiedBy>Parinita Agarwal</cp:lastModifiedBy>
  <cp:revision>32</cp:revision>
  <dcterms:created xsi:type="dcterms:W3CDTF">2017-01-16T10:00:42Z</dcterms:created>
  <dcterms:modified xsi:type="dcterms:W3CDTF">2018-04-04T12:24:32Z</dcterms:modified>
</cp:coreProperties>
</file>